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738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8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29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677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143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665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526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959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231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296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007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948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955923-DE92-4BB2-9C1D-73284842C1C0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29F16-4867-426B-B969-F974B1AF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714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FA64922-378E-4CDE-989C-B3CA82BADD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837932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b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Literature search summary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8DF9659-2980-46D3-99DE-68B5D02A472E}"/>
              </a:ext>
            </a:extLst>
          </p:cNvPr>
          <p:cNvSpPr txBox="1"/>
          <p:nvPr/>
        </p:nvSpPr>
        <p:spPr>
          <a:xfrm>
            <a:off x="2296046" y="1394191"/>
            <a:ext cx="2282997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ubMed search results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n=789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CE77AE1-55AD-46ED-A2C2-86BDBA15A29B}"/>
              </a:ext>
            </a:extLst>
          </p:cNvPr>
          <p:cNvSpPr txBox="1"/>
          <p:nvPr/>
        </p:nvSpPr>
        <p:spPr>
          <a:xfrm>
            <a:off x="4387990" y="2165835"/>
            <a:ext cx="174438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uplicate articles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n=129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BBC500-E6E9-4E52-BDC8-BB7335F39281}"/>
              </a:ext>
            </a:extLst>
          </p:cNvPr>
          <p:cNvSpPr txBox="1"/>
          <p:nvPr/>
        </p:nvSpPr>
        <p:spPr>
          <a:xfrm>
            <a:off x="2622257" y="2937479"/>
            <a:ext cx="1630575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nal screening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n=660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1857C7B-EA40-495D-8BB6-38D2812403AE}"/>
              </a:ext>
            </a:extLst>
          </p:cNvPr>
          <p:cNvSpPr txBox="1"/>
          <p:nvPr/>
        </p:nvSpPr>
        <p:spPr>
          <a:xfrm>
            <a:off x="1823962" y="4480767"/>
            <a:ext cx="3227165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view of abstracts / titles</a:t>
            </a:r>
            <a:b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 identify relevant clinical studies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n=97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99E63A-B5B6-42B2-B300-5653D4FC2FF4}"/>
              </a:ext>
            </a:extLst>
          </p:cNvPr>
          <p:cNvSpPr txBox="1"/>
          <p:nvPr/>
        </p:nvSpPr>
        <p:spPr>
          <a:xfrm>
            <a:off x="4141929" y="3709122"/>
            <a:ext cx="22365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moved at screening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n=563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19CBB4-F706-4118-B397-54806B73D33D}"/>
              </a:ext>
            </a:extLst>
          </p:cNvPr>
          <p:cNvSpPr txBox="1"/>
          <p:nvPr/>
        </p:nvSpPr>
        <p:spPr>
          <a:xfrm>
            <a:off x="1584312" y="6270276"/>
            <a:ext cx="3706464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uthor reviewed and identified studies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n=18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79F497E6-3AEA-42D0-8E0B-8F0982CBAF5E}"/>
              </a:ext>
            </a:extLst>
          </p:cNvPr>
          <p:cNvCxnSpPr>
            <a:stCxn id="5" idx="2"/>
            <a:endCxn id="7" idx="0"/>
          </p:cNvCxnSpPr>
          <p:nvPr/>
        </p:nvCxnSpPr>
        <p:spPr>
          <a:xfrm>
            <a:off x="3437545" y="1978966"/>
            <a:ext cx="0" cy="95851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ACF8F82-46F8-4EA2-9DBB-F58D2B6DB685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3437545" y="3522254"/>
            <a:ext cx="0" cy="95851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645FF717-EA5D-42B5-9989-DB50E410C436}"/>
              </a:ext>
            </a:extLst>
          </p:cNvPr>
          <p:cNvCxnSpPr>
            <a:cxnSpLocks/>
            <a:stCxn id="8" idx="2"/>
            <a:endCxn id="10" idx="0"/>
          </p:cNvCxnSpPr>
          <p:nvPr/>
        </p:nvCxnSpPr>
        <p:spPr>
          <a:xfrm flipH="1">
            <a:off x="3437544" y="5311764"/>
            <a:ext cx="1" cy="95851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CC8CD82A-0CE0-4A6F-92E1-C03937CFD798}"/>
              </a:ext>
            </a:extLst>
          </p:cNvPr>
          <p:cNvCxnSpPr>
            <a:cxnSpLocks/>
            <a:endCxn id="6" idx="1"/>
          </p:cNvCxnSpPr>
          <p:nvPr/>
        </p:nvCxnSpPr>
        <p:spPr>
          <a:xfrm>
            <a:off x="3420456" y="2458223"/>
            <a:ext cx="96753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9EEC3B51-99E9-4059-BFED-7BD3F033E3A4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3437544" y="4001510"/>
            <a:ext cx="70438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4786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63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ry Figure 1 Literature search summar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 Literature search summary</dc:title>
  <dc:creator>Ian Morgan</dc:creator>
  <cp:lastModifiedBy>Ian Morgan</cp:lastModifiedBy>
  <cp:revision>1</cp:revision>
  <dcterms:created xsi:type="dcterms:W3CDTF">2021-12-14T15:23:45Z</dcterms:created>
  <dcterms:modified xsi:type="dcterms:W3CDTF">2021-12-14T15:31:14Z</dcterms:modified>
</cp:coreProperties>
</file>